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7140" autoAdjust="0"/>
  </p:normalViewPr>
  <p:slideViewPr>
    <p:cSldViewPr snapToGrid="0">
      <p:cViewPr varScale="1">
        <p:scale>
          <a:sx n="69" d="100"/>
          <a:sy n="69" d="100"/>
        </p:scale>
        <p:origin x="11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891BFA-07A5-4DB3-BF1D-B6F337630842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2A77A8-36BD-45B8-AC2F-FB108759DF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41577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2A77A8-36BD-45B8-AC2F-FB108759DF4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84137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2A77A8-36BD-45B8-AC2F-FB108759DF4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30551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C9643A-AE21-40A8-873E-A75B8D2FD8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25C40CE-FC43-4FAE-BB53-1134D38B0D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A897E0-BAB1-4C31-9526-7052460C3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00B2DF-7574-47D6-A1C5-9ED944B6E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5FCADF-28E0-4E9D-8612-C37FD728B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4687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9E7FF6-6647-4F9B-B7A8-54B922F9D0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3C4903B-EF3B-4126-90F2-9E19CC5F3B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7862C1-CE38-414E-A8E9-E9E7FD5F4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B1ED67-E321-447D-AC64-782B25CF5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17AAB8-D440-4A99-B804-20C1D3C5B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8417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743E10D-F1BD-400B-8E47-BB26964B03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A5DB7A8-3905-441E-AED6-60214F791F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18936F-39FD-4CC2-8549-0F835C56F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D796F4-5389-46D0-B6E1-65B0DBB48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76C664-0C15-411B-893F-48D0DBD04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027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E4A5AF-23E4-40C9-A130-237BE85E18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0AC789D-4C57-45BF-A08D-A73838FD6F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C588E9-3FE8-4C8F-BCCD-24291E17A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5C969D-7919-47CD-BE8B-9499888AD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BB89EB-340F-4CD4-AC03-A0169EE9B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5084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A60089-DCBF-442B-88BF-724CFC849D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6ABBC8-972B-41A2-B242-E3715BA418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7B473E-D213-435A-8E8F-8887CDDAF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FBDD89D-6A05-45B1-B8C0-E54F230AB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7C0687-F2A3-491F-81A5-02F8D2BA2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0309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CA57C5-F8E5-40CB-8EBE-F20F2CFACB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7ACF503-514B-47FA-9D71-926FAEBE30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86406D5-7489-4156-84DA-4B55085BA6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9EEE755-A9CC-4EB5-A6CB-C14192830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2330AF2-329B-4FF6-B269-E91480B80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3408726-5BA2-4113-B421-23B5D9456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9165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C56575-FEB7-49C6-9F71-F9649B3EF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D8D3A9-B38B-488F-BD94-B3EA85CC39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CD1ED6D-42D6-4187-80B1-01F9BA7F8D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17CF56D-CBD1-4B5B-852C-202C1F41D3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329941C-2379-4B76-BE5F-CA4A4C8FF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0FDBE14-44E9-49EF-8F53-EF2CD24C4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3E53439-F07A-4EE8-8A48-6131EB3C0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094791A-E4A0-4481-8081-15F0EFD37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4869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C179ED-BBC9-4E5D-8248-51CF2DA536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0E13B1F-E9A7-43CC-AA0A-30D5F3835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213DFF5-EEA7-4687-A340-C2269F1A7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3E55152-8D1F-49CF-906D-903A0BE3D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5555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23EECF1-F215-44E6-A774-AE141F6D8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4A89B67-3E95-4374-8A60-53E23273C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88ADD47-C1FD-4637-BA23-83AD33B7D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198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36FFD4-8407-41EC-8C9A-FEE88A287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297FFD-3ECC-48F3-B0FB-01DD3E9005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A9B75E6-4438-4788-A717-D5C551DFE1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77103F-6CC6-4EBF-80FB-184F9C07A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BE7419-5B83-4307-9DD6-14656052C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7D160B9-F911-4453-BF87-11794DFA2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6222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BA36D3-C3AA-4E88-B531-E5D132E5F0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BAEFFA7-8CD0-4C12-A17F-3A86E5EC2F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12093E0-C6AF-4497-ABC2-34FD9B154E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A205E7-89E1-415A-9232-93736C83D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EF07DB-3927-4CA7-8CFC-7185131BD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B1385D-2EA7-4177-8851-4ACD3F482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0413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1B4C7D5-0791-45D6-BD4B-1C2283A15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751706-93D2-4174-B781-4A25858618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78A76B-5EE7-4FAB-BA48-9691B66242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F0283-C963-46E2-8EA0-B05C6AAE060E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4B0078-BC3C-4985-ACC6-FFF5516056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4A2989-B58B-4809-AB61-D8D8C035D0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0C9533-0A33-4071-8F09-2CEBEDF36D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2940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02CE618-C0E3-4FF8-A41C-090A1D5FB961}"/>
              </a:ext>
            </a:extLst>
          </p:cNvPr>
          <p:cNvGrpSpPr/>
          <p:nvPr/>
        </p:nvGrpSpPr>
        <p:grpSpPr>
          <a:xfrm>
            <a:off x="165328" y="-516818"/>
            <a:ext cx="7543178" cy="5932208"/>
            <a:chOff x="2459238" y="493864"/>
            <a:chExt cx="7543178" cy="5932208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E5706989-65F9-4910-961E-9B4ADF227F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9238" y="2727860"/>
              <a:ext cx="7543178" cy="3698212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791FFE0-E183-452D-B7AE-9E5160477D03}"/>
                </a:ext>
              </a:extLst>
            </p:cNvPr>
            <p:cNvSpPr txBox="1"/>
            <p:nvPr/>
          </p:nvSpPr>
          <p:spPr>
            <a:xfrm rot="18075157">
              <a:off x="5501837" y="1413446"/>
              <a:ext cx="21777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Scramble-shRNA</a:t>
              </a:r>
              <a:endParaRPr lang="zh-CN" altLang="en-US" sz="1600" b="1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BAC02A8-48C5-4320-9544-06C3DDA7C29C}"/>
                </a:ext>
              </a:extLst>
            </p:cNvPr>
            <p:cNvSpPr txBox="1"/>
            <p:nvPr/>
          </p:nvSpPr>
          <p:spPr>
            <a:xfrm rot="18075157">
              <a:off x="6097437" y="1413442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1</a:t>
              </a:r>
              <a:endParaRPr lang="zh-CN" altLang="en-US" sz="1600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44CB8EC-586D-46AA-8F52-4FD4E334399E}"/>
                </a:ext>
              </a:extLst>
            </p:cNvPr>
            <p:cNvSpPr txBox="1"/>
            <p:nvPr/>
          </p:nvSpPr>
          <p:spPr>
            <a:xfrm rot="18075157">
              <a:off x="6687092" y="1413443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2</a:t>
              </a:r>
              <a:endParaRPr lang="zh-CN" altLang="en-US" sz="1600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9227B049-E128-4C94-80E8-EB2A0E8926B2}"/>
                </a:ext>
              </a:extLst>
            </p:cNvPr>
            <p:cNvSpPr txBox="1"/>
            <p:nvPr/>
          </p:nvSpPr>
          <p:spPr>
            <a:xfrm rot="18075157">
              <a:off x="7222754" y="1413444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3</a:t>
              </a:r>
              <a:endParaRPr lang="zh-CN" altLang="en-US" sz="1600" b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019F755-5C7E-4469-BE4C-AD63BAA8A869}"/>
                </a:ext>
              </a:extLst>
            </p:cNvPr>
            <p:cNvSpPr txBox="1"/>
            <p:nvPr/>
          </p:nvSpPr>
          <p:spPr>
            <a:xfrm rot="18075157">
              <a:off x="7866403" y="1413445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4</a:t>
              </a:r>
              <a:endParaRPr lang="zh-CN" altLang="en-US" sz="1600" b="1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C6C0CF98-A67E-4A7B-920F-F5ED6E2899B1}"/>
                </a:ext>
              </a:extLst>
            </p:cNvPr>
            <p:cNvSpPr txBox="1"/>
            <p:nvPr/>
          </p:nvSpPr>
          <p:spPr>
            <a:xfrm rot="18075157">
              <a:off x="8415038" y="1472557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5</a:t>
              </a:r>
              <a:endParaRPr lang="zh-CN" altLang="en-US" sz="16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13DC55E-379B-4FAC-8807-912DE0993FA3}"/>
                </a:ext>
              </a:extLst>
            </p:cNvPr>
            <p:cNvSpPr txBox="1"/>
            <p:nvPr/>
          </p:nvSpPr>
          <p:spPr>
            <a:xfrm>
              <a:off x="5959226" y="2791567"/>
              <a:ext cx="15410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600" b="1" dirty="0"/>
                <a:t>β-</a:t>
              </a:r>
              <a:r>
                <a:rPr lang="en-US" altLang="zh-CN" sz="1600" b="1" dirty="0"/>
                <a:t>actin (42KD)</a:t>
              </a:r>
              <a:endParaRPr lang="zh-CN" altLang="en-US" sz="1600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8123190-59F1-41D0-9976-997C9A771B11}"/>
                </a:ext>
              </a:extLst>
            </p:cNvPr>
            <p:cNvSpPr txBox="1"/>
            <p:nvPr/>
          </p:nvSpPr>
          <p:spPr>
            <a:xfrm>
              <a:off x="5881067" y="4238412"/>
              <a:ext cx="15410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 (26KD)</a:t>
              </a:r>
              <a:endParaRPr lang="zh-CN" altLang="en-US" sz="1600" b="1" dirty="0"/>
            </a:p>
          </p:txBody>
        </p:sp>
      </p:grpSp>
      <p:sp>
        <p:nvSpPr>
          <p:cNvPr id="18" name="内容占位符 4">
            <a:extLst>
              <a:ext uri="{FF2B5EF4-FFF2-40B4-BE49-F238E27FC236}">
                <a16:creationId xmlns:a16="http://schemas.microsoft.com/office/drawing/2014/main" id="{E70C5E47-0E66-4DF6-AA18-8E9F7D8B96E6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284729" y="5583719"/>
            <a:ext cx="1107273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/>
              <a:t>Additional file 1: Supplementary Figure 1. Uncropped western blots used in Fig. 3B. The figure shows all original uncropped blots. The western blots of KLRG1-shRNA3-5 were not shown in the manuscript and Fig. 3B, because they did not shown significant knockdown efficacy. Blots were cropped where indicated by the red lines.</a:t>
            </a: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1F20E2A7-1DD9-48C2-90FD-5FB8422951EC}"/>
              </a:ext>
            </a:extLst>
          </p:cNvPr>
          <p:cNvCxnSpPr>
            <a:cxnSpLocks/>
          </p:cNvCxnSpPr>
          <p:nvPr/>
        </p:nvCxnSpPr>
        <p:spPr>
          <a:xfrm>
            <a:off x="7031428" y="4049495"/>
            <a:ext cx="423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E15275C4-7E56-4FEF-BD49-0329D5A03F2F}"/>
              </a:ext>
            </a:extLst>
          </p:cNvPr>
          <p:cNvSpPr txBox="1"/>
          <p:nvPr/>
        </p:nvSpPr>
        <p:spPr>
          <a:xfrm>
            <a:off x="7708506" y="3880907"/>
            <a:ext cx="7316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25KD</a:t>
            </a:r>
            <a:endParaRPr lang="zh-CN" altLang="en-US" sz="1600" b="1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A6C0F74E-1C4C-4FC7-AE65-7F10F76411D0}"/>
              </a:ext>
            </a:extLst>
          </p:cNvPr>
          <p:cNvCxnSpPr>
            <a:cxnSpLocks/>
          </p:cNvCxnSpPr>
          <p:nvPr/>
        </p:nvCxnSpPr>
        <p:spPr>
          <a:xfrm>
            <a:off x="7031428" y="3091028"/>
            <a:ext cx="423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92A4C2BA-4536-471C-8B16-0E7CABE02F05}"/>
              </a:ext>
            </a:extLst>
          </p:cNvPr>
          <p:cNvCxnSpPr>
            <a:cxnSpLocks/>
          </p:cNvCxnSpPr>
          <p:nvPr/>
        </p:nvCxnSpPr>
        <p:spPr>
          <a:xfrm>
            <a:off x="7031428" y="2077474"/>
            <a:ext cx="423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794BB44E-B4D9-4A8E-9F49-1D956D4F01D5}"/>
              </a:ext>
            </a:extLst>
          </p:cNvPr>
          <p:cNvCxnSpPr>
            <a:cxnSpLocks/>
          </p:cNvCxnSpPr>
          <p:nvPr/>
        </p:nvCxnSpPr>
        <p:spPr>
          <a:xfrm>
            <a:off x="7031428" y="4633389"/>
            <a:ext cx="423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矩形 5">
            <a:extLst>
              <a:ext uri="{FF2B5EF4-FFF2-40B4-BE49-F238E27FC236}">
                <a16:creationId xmlns:a16="http://schemas.microsoft.com/office/drawing/2014/main" id="{A89131F8-A96B-47D7-8790-09FCE1DF3CCD}"/>
              </a:ext>
            </a:extLst>
          </p:cNvPr>
          <p:cNvSpPr/>
          <p:nvPr/>
        </p:nvSpPr>
        <p:spPr>
          <a:xfrm>
            <a:off x="3225385" y="2119439"/>
            <a:ext cx="2018853" cy="9715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noFill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8497A79-53F3-49AB-B0EE-94E77CD7CBAA}"/>
              </a:ext>
            </a:extLst>
          </p:cNvPr>
          <p:cNvSpPr/>
          <p:nvPr/>
        </p:nvSpPr>
        <p:spPr>
          <a:xfrm>
            <a:off x="3157484" y="3594623"/>
            <a:ext cx="2018853" cy="62483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noFill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20A5FD5-26E7-422D-994B-82086270E5D9}"/>
              </a:ext>
            </a:extLst>
          </p:cNvPr>
          <p:cNvSpPr txBox="1"/>
          <p:nvPr/>
        </p:nvSpPr>
        <p:spPr>
          <a:xfrm>
            <a:off x="7724517" y="4478871"/>
            <a:ext cx="7316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15KD</a:t>
            </a:r>
            <a:endParaRPr lang="zh-CN" altLang="en-US" sz="16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42E23A3-90CC-4A69-A6CB-E1114698FC70}"/>
              </a:ext>
            </a:extLst>
          </p:cNvPr>
          <p:cNvSpPr txBox="1"/>
          <p:nvPr/>
        </p:nvSpPr>
        <p:spPr>
          <a:xfrm>
            <a:off x="7720789" y="2921751"/>
            <a:ext cx="7316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40KD</a:t>
            </a:r>
            <a:endParaRPr lang="zh-CN" altLang="en-US" sz="16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70E2400-552F-4C51-88B5-135795D142A0}"/>
              </a:ext>
            </a:extLst>
          </p:cNvPr>
          <p:cNvSpPr txBox="1"/>
          <p:nvPr/>
        </p:nvSpPr>
        <p:spPr>
          <a:xfrm>
            <a:off x="7720789" y="1907189"/>
            <a:ext cx="7316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55KD</a:t>
            </a:r>
            <a:endParaRPr lang="zh-CN" altLang="en-US" sz="16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6C0D1BD-50D3-444D-9CD0-04033746536C}"/>
              </a:ext>
            </a:extLst>
          </p:cNvPr>
          <p:cNvSpPr txBox="1"/>
          <p:nvPr/>
        </p:nvSpPr>
        <p:spPr>
          <a:xfrm>
            <a:off x="9690816" y="631152"/>
            <a:ext cx="15410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A549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9633060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851CB57F-5704-4C8F-9BB9-45D4E7639DC4}"/>
              </a:ext>
            </a:extLst>
          </p:cNvPr>
          <p:cNvGrpSpPr/>
          <p:nvPr/>
        </p:nvGrpSpPr>
        <p:grpSpPr>
          <a:xfrm>
            <a:off x="575204" y="130118"/>
            <a:ext cx="4384721" cy="4372781"/>
            <a:chOff x="575204" y="130118"/>
            <a:chExt cx="4384721" cy="4372781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644FC43C-3617-40B6-B147-31C2C2D1C9C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5204" y="1799807"/>
              <a:ext cx="4384721" cy="2703092"/>
            </a:xfrm>
            <a:prstGeom prst="rect">
              <a:avLst/>
            </a:prstGeom>
          </p:spPr>
        </p:pic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45E1AA7E-B254-480D-AEB9-F12A63482B60}"/>
                </a:ext>
              </a:extLst>
            </p:cNvPr>
            <p:cNvSpPr/>
            <p:nvPr/>
          </p:nvSpPr>
          <p:spPr>
            <a:xfrm>
              <a:off x="2341419" y="2292042"/>
              <a:ext cx="1593272" cy="62483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n>
                  <a:solidFill>
                    <a:srgbClr val="FF0000"/>
                  </a:solidFill>
                </a:ln>
                <a:noFill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8EB2FA71-5CE5-4D74-AF59-AFAAE1D366D5}"/>
                </a:ext>
              </a:extLst>
            </p:cNvPr>
            <p:cNvSpPr/>
            <p:nvPr/>
          </p:nvSpPr>
          <p:spPr>
            <a:xfrm>
              <a:off x="2355274" y="3199188"/>
              <a:ext cx="1593272" cy="62483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n>
                  <a:solidFill>
                    <a:srgbClr val="FF0000"/>
                  </a:solidFill>
                </a:ln>
                <a:noFill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F56441B-A493-4DEA-9CE9-649657F0DB2B}"/>
                </a:ext>
              </a:extLst>
            </p:cNvPr>
            <p:cNvSpPr txBox="1"/>
            <p:nvPr/>
          </p:nvSpPr>
          <p:spPr>
            <a:xfrm rot="18075157">
              <a:off x="1962188" y="1049700"/>
              <a:ext cx="21777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Scramble-shRNA</a:t>
              </a:r>
              <a:endParaRPr lang="zh-CN" altLang="en-US" sz="1600" b="1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7E034DEF-0261-4922-92EF-458AC0F5C6FD}"/>
                </a:ext>
              </a:extLst>
            </p:cNvPr>
            <p:cNvSpPr txBox="1"/>
            <p:nvPr/>
          </p:nvSpPr>
          <p:spPr>
            <a:xfrm rot="18075157">
              <a:off x="2557788" y="1049696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1</a:t>
              </a:r>
              <a:endParaRPr lang="zh-CN" altLang="en-US" sz="1600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1656F572-6885-47D6-B2C1-66783A5A5C2B}"/>
                </a:ext>
              </a:extLst>
            </p:cNvPr>
            <p:cNvSpPr txBox="1"/>
            <p:nvPr/>
          </p:nvSpPr>
          <p:spPr>
            <a:xfrm rot="18075157">
              <a:off x="3147443" y="1049697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2</a:t>
              </a:r>
              <a:endParaRPr lang="zh-CN" altLang="en-US" sz="1600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C0772969-3817-4813-890D-32E74154C8C0}"/>
                </a:ext>
              </a:extLst>
            </p:cNvPr>
            <p:cNvSpPr txBox="1"/>
            <p:nvPr/>
          </p:nvSpPr>
          <p:spPr>
            <a:xfrm rot="18075157">
              <a:off x="289913" y="1104091"/>
              <a:ext cx="21777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Scramble-shRNA</a:t>
              </a:r>
              <a:endParaRPr lang="zh-CN" altLang="en-US" sz="1600" b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214AD52-BE8E-4676-BEF9-51F6D87123DC}"/>
                </a:ext>
              </a:extLst>
            </p:cNvPr>
            <p:cNvSpPr txBox="1"/>
            <p:nvPr/>
          </p:nvSpPr>
          <p:spPr>
            <a:xfrm rot="18075157">
              <a:off x="885513" y="1104087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1</a:t>
              </a:r>
              <a:endParaRPr lang="zh-CN" altLang="en-US" sz="1600" b="1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95B1DED-030E-465F-A250-86B16FC5663E}"/>
                </a:ext>
              </a:extLst>
            </p:cNvPr>
            <p:cNvSpPr txBox="1"/>
            <p:nvPr/>
          </p:nvSpPr>
          <p:spPr>
            <a:xfrm rot="18075157">
              <a:off x="1475168" y="1104088"/>
              <a:ext cx="21777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KLRG1-shRNA-2</a:t>
              </a:r>
              <a:endParaRPr lang="zh-CN" altLang="en-US" sz="1600" b="1" dirty="0"/>
            </a:p>
          </p:txBody>
        </p:sp>
      </p:grpSp>
      <p:sp>
        <p:nvSpPr>
          <p:cNvPr id="15" name="内容占位符 4">
            <a:extLst>
              <a:ext uri="{FF2B5EF4-FFF2-40B4-BE49-F238E27FC236}">
                <a16:creationId xmlns:a16="http://schemas.microsoft.com/office/drawing/2014/main" id="{201AC229-D4EE-4411-A445-8808AA5D5C19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284729" y="5583719"/>
            <a:ext cx="1107273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/>
              <a:t>Additional file :1 Supplementary Figure 2. Uncropped western blots used in Fig. 3E. The figure shows all original uncropped blots. Blots were cropped where indicated by the red lines.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074D189-7EBF-4A23-ABFC-A8776A9A98AA}"/>
              </a:ext>
            </a:extLst>
          </p:cNvPr>
          <p:cNvSpPr txBox="1"/>
          <p:nvPr/>
        </p:nvSpPr>
        <p:spPr>
          <a:xfrm>
            <a:off x="2484287" y="2817551"/>
            <a:ext cx="15410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b="1" dirty="0"/>
              <a:t>β-</a:t>
            </a:r>
            <a:r>
              <a:rPr lang="en-US" altLang="zh-CN" sz="1600" b="1" dirty="0"/>
              <a:t>actin (42KD)</a:t>
            </a:r>
            <a:endParaRPr lang="zh-CN" altLang="en-US" sz="16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053706F-D164-4B33-B3D5-13F623AE2BBD}"/>
              </a:ext>
            </a:extLst>
          </p:cNvPr>
          <p:cNvSpPr txBox="1"/>
          <p:nvPr/>
        </p:nvSpPr>
        <p:spPr>
          <a:xfrm>
            <a:off x="2472597" y="4025882"/>
            <a:ext cx="15410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KLRG1 (26KD)</a:t>
            </a:r>
            <a:endParaRPr lang="zh-CN" altLang="en-US" sz="1600" b="1" dirty="0"/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2F6EE597-AFA5-4DF4-9742-F2DC8B790B52}"/>
              </a:ext>
            </a:extLst>
          </p:cNvPr>
          <p:cNvCxnSpPr>
            <a:cxnSpLocks/>
          </p:cNvCxnSpPr>
          <p:nvPr/>
        </p:nvCxnSpPr>
        <p:spPr>
          <a:xfrm>
            <a:off x="4333254" y="3526481"/>
            <a:ext cx="423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814310BC-4EF7-4CB6-94D1-A682B01D17E2}"/>
              </a:ext>
            </a:extLst>
          </p:cNvPr>
          <p:cNvSpPr txBox="1"/>
          <p:nvPr/>
        </p:nvSpPr>
        <p:spPr>
          <a:xfrm>
            <a:off x="4871782" y="3371748"/>
            <a:ext cx="7316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25KD</a:t>
            </a:r>
            <a:endParaRPr lang="zh-CN" altLang="en-US" sz="1600" b="1" dirty="0"/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70323225-D35A-4906-BCE7-22AC863F906F}"/>
              </a:ext>
            </a:extLst>
          </p:cNvPr>
          <p:cNvCxnSpPr>
            <a:cxnSpLocks/>
          </p:cNvCxnSpPr>
          <p:nvPr/>
        </p:nvCxnSpPr>
        <p:spPr>
          <a:xfrm>
            <a:off x="4333261" y="2872806"/>
            <a:ext cx="423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5371FFD7-6C91-4278-A64B-03D7F3E6194C}"/>
              </a:ext>
            </a:extLst>
          </p:cNvPr>
          <p:cNvCxnSpPr>
            <a:cxnSpLocks/>
          </p:cNvCxnSpPr>
          <p:nvPr/>
        </p:nvCxnSpPr>
        <p:spPr>
          <a:xfrm>
            <a:off x="4333261" y="2330316"/>
            <a:ext cx="423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AA825E93-052D-49DD-A3F7-E7F96A338CE3}"/>
              </a:ext>
            </a:extLst>
          </p:cNvPr>
          <p:cNvCxnSpPr>
            <a:cxnSpLocks/>
          </p:cNvCxnSpPr>
          <p:nvPr/>
        </p:nvCxnSpPr>
        <p:spPr>
          <a:xfrm>
            <a:off x="4333254" y="4041100"/>
            <a:ext cx="423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0657A889-CA4B-40C3-849C-C66074B056EE}"/>
              </a:ext>
            </a:extLst>
          </p:cNvPr>
          <p:cNvSpPr txBox="1"/>
          <p:nvPr/>
        </p:nvSpPr>
        <p:spPr>
          <a:xfrm>
            <a:off x="4887793" y="3969712"/>
            <a:ext cx="7316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15KD</a:t>
            </a:r>
            <a:endParaRPr lang="zh-CN" altLang="en-US" sz="16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04F22AB-91E0-4C53-8620-3D28204AD8C0}"/>
              </a:ext>
            </a:extLst>
          </p:cNvPr>
          <p:cNvSpPr txBox="1"/>
          <p:nvPr/>
        </p:nvSpPr>
        <p:spPr>
          <a:xfrm>
            <a:off x="4842507" y="2703532"/>
            <a:ext cx="7316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40KD</a:t>
            </a:r>
            <a:endParaRPr lang="zh-CN" altLang="en-US" sz="1600" b="1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7B006B7-7EE7-431C-A89F-CDC18FDA20BC}"/>
              </a:ext>
            </a:extLst>
          </p:cNvPr>
          <p:cNvSpPr txBox="1"/>
          <p:nvPr/>
        </p:nvSpPr>
        <p:spPr>
          <a:xfrm>
            <a:off x="4842507" y="2146170"/>
            <a:ext cx="7316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55KD</a:t>
            </a:r>
            <a:endParaRPr lang="zh-CN" altLang="en-US" sz="16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614ADCF-AB48-4680-94B0-122F63236230}"/>
              </a:ext>
            </a:extLst>
          </p:cNvPr>
          <p:cNvSpPr txBox="1"/>
          <p:nvPr/>
        </p:nvSpPr>
        <p:spPr>
          <a:xfrm>
            <a:off x="6975325" y="880419"/>
            <a:ext cx="15410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H1299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05001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137</Words>
  <Application>Microsoft Office PowerPoint</Application>
  <PresentationFormat>宽屏</PresentationFormat>
  <Paragraphs>30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 guanghua</dc:creator>
  <cp:lastModifiedBy>liu guanghua</cp:lastModifiedBy>
  <cp:revision>11</cp:revision>
  <dcterms:created xsi:type="dcterms:W3CDTF">2020-08-17T10:48:46Z</dcterms:created>
  <dcterms:modified xsi:type="dcterms:W3CDTF">2021-03-30T13:14:19Z</dcterms:modified>
</cp:coreProperties>
</file>